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74CDA4-1748-42DB-51D9-1E0A486AB7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6F30853-9D11-AD2B-DF85-1F5CF53933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F94973-F830-F64B-6D49-F27690F27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68E6EE-B4D1-BD51-BF4E-D235C5ECC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D3E931-0AE2-6051-ABE5-B0081AC23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9109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4E8C2D-0275-D57E-169D-A522C17067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DC1BB96-3613-6CA6-FC5F-665538EA01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42AD11E-6862-55C5-1D44-5DD0CF7AFA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C7AD0E-7B33-75CD-B5A0-5075038F9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A18C9B-5450-B339-EC55-190F6F912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916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C5B6C9B-9DC6-8F7A-D532-436A79BDBC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609BC5C-F78E-D2F3-2559-2487C92F85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8BB85C-C48B-A0EA-485C-B0BB607AA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4FB1F9D-FB4E-7BC2-D01E-ABFAD4F14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8ACCBF-959A-8751-2FC7-CC37C2CA6E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5137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0FCDA8-B44E-9CCD-6C0A-340023107C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CFB441-3ACD-80EA-7469-17F7427966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026B7D-4695-554B-8917-E6DDCA37F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FA68BCE-7113-0A09-1464-C0F18FB6AB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E25B34-842D-7911-647A-134734B96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936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ED3944-A814-1257-F4F2-F326AED90E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2B25CF-6618-159B-60EA-29D4880B41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D085B4-3FF2-6F32-2B8D-A21637E3C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AB3A1CE-01D7-B03A-F51B-4FF84A4A0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C67E33-D9ED-38A7-8C5C-D79400B24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8877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C6B623-511E-848D-155F-129435E4AF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1C8759-F07B-BAFF-38AB-8BBC13C9DA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86FDFFA-B002-D6D2-14E9-913C60EDC7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1F8EB9E-C777-6251-DCE5-4FB62E167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F8B52E1-B4CF-FF78-20AD-B5FCA4E02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F910E48-04AE-2233-3DCF-A98E14999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8221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3440B7-58EE-0E48-FD9C-3036A9CFC4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5FD1560-FF94-5D2B-A221-BC367F006C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D033622-21E8-D647-27DA-BE55B69BB7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586A6D4-40D4-F977-2B29-02C8287F67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CB4E36B-E52D-1B0E-961A-9CEA3F823A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F8A6C6F-8783-B2AE-FA3B-C8E00FB9B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69C9A6E-FAB1-E4B7-5A63-7803BDC7F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49A7064-47DF-3C03-17DF-359C364C4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4533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6E89C3-13D6-8284-2A15-77F61A8CAC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DB0A2B2-2945-ADAD-8306-7B2C17910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05898F5-B637-F9C7-956D-2CF181FDF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C63E61D-2024-EBF3-323E-06007B373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8414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65A2AA7-6382-0CC1-55A6-EC8B174CD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EAAFB49-69A7-494E-76CB-36084B350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F2C4F43-261B-A8F3-82E2-5340BD3E3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8120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A0B524-98A0-2A5B-B2B6-9FF0C5DE1F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B621D9A-A447-084F-4A5D-AF7FB3B0A6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E6DB677-8644-8E41-0C5A-D97D28A848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35E4B64-B8BA-6213-E187-2F8E28F6C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A0B8CB3-DF87-B9AD-CA3C-9B141FBC4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09FC85F-A45A-3F46-1E9C-BCA198C3B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1557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4900AE-C2E0-FB35-D7CF-FC83EFCCE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E993C58-C803-99AA-027C-DBCB918863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3E85EB3-4C4D-A368-1DC4-2C48DBBF75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DEEB7EA-42F8-0E86-6FDB-730FEA9F5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8B8C1A4-CBCC-74BF-BD33-4539685A5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5B29422-B1C5-12B2-6E7C-A8DDF7E78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30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D1F827D-D1BD-D50F-80D3-343B12AD3B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7EAEA8B-4FB5-ED87-7E4D-169A382B62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11EED3-9B35-355F-A8DD-5EB052B004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8B221-D7BD-4DC3-9C43-471D3AC3AE11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EB3DD3-3A1F-6BF4-F4F0-6ECD8FB4E6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369592-8B1F-0395-14E8-5C48C59E2B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96304-9307-4752-AE21-8727FEF311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0958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EE50477-40A5-753A-5706-A85772DADC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6333" y="551097"/>
            <a:ext cx="9059334" cy="452966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1075962D-300E-CE1D-ABC2-7225589C5183}"/>
              </a:ext>
            </a:extLst>
          </p:cNvPr>
          <p:cNvSpPr txBox="1"/>
          <p:nvPr/>
        </p:nvSpPr>
        <p:spPr>
          <a:xfrm>
            <a:off x="1566333" y="5394800"/>
            <a:ext cx="9145155" cy="12311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4. </a:t>
            </a:r>
            <a:r>
              <a:rPr lang="en-US" altLang="zh-CN" sz="14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oad diagram of joint part elements.</a:t>
            </a:r>
            <a:r>
              <a:rPr lang="en-US" altLang="zh-CN" sz="14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metabolome data are on the left and the transcriptome data are on the right. Each dot represents a gene or a metabolite. The horizontal coordinate is the first one-dimensional coordinate of the joint part, and the vertical coordinate is the second two-dimensional coordinate of the joint part. The greater the absolute value of an element in its coordinates, the greater the degree of association that element has with another omics.</a:t>
            </a:r>
            <a:endParaRPr lang="zh-CN" altLang="zh-CN" sz="140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800"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608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9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靖欣 霍</dc:creator>
  <cp:lastModifiedBy>靖欣 霍</cp:lastModifiedBy>
  <cp:revision>2</cp:revision>
  <dcterms:created xsi:type="dcterms:W3CDTF">2024-06-28T06:43:39Z</dcterms:created>
  <dcterms:modified xsi:type="dcterms:W3CDTF">2024-06-28T06:48:17Z</dcterms:modified>
</cp:coreProperties>
</file>